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AE3B0212-8FB2-EAFC-CCB8-AA3A4A2972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35224" y="3562862"/>
            <a:ext cx="9921551" cy="456486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 Forest plot of NRS2002 score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80B9980E-5935-3AEE-D1FF-40CBFAFE961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862138" y="1150776"/>
            <a:ext cx="8467725" cy="1938499"/>
            <a:chOff x="1173" y="980"/>
            <a:chExt cx="5334" cy="966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ACD1034A-14C8-5165-DC47-2D7DB1BB1956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73" y="980"/>
              <a:ext cx="5334" cy="9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2266173A-A6D7-D029-0190-F2C08B0318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3" y="980"/>
              <a:ext cx="5334" cy="966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E135C6B2-7292-1EEC-EB16-9D8F6A5484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3" y="1173"/>
              <a:ext cx="533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EBD90BF6-F45D-209E-A514-3406509A9B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100"/>
              <a:ext cx="76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A24BB44C-62FE-27AF-D29D-7EC4C30B1B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207"/>
              <a:ext cx="33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7FC57564-2620-AEB4-5FA6-9F549EE10A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304"/>
              <a:ext cx="2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u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F9BEEA5B-B2BC-6AB0-50D7-130348B35E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400"/>
              <a:ext cx="4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CB57F1EA-43B6-9B6B-572F-2563D53C3C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583"/>
              <a:ext cx="563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DC570DBC-BF23-3EDA-E79F-05954D1C7B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690"/>
              <a:ext cx="254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Tau² = 0.90; Chi² = 72.89, df = 2 (P &lt; 0.00001); I² = 9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E9131D15-B3AB-6A50-29EF-7A7E6DD9E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3" y="1787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1.22 (P = 0.22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A842E092-68A6-F82D-8F46-56A7F18A1B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6" y="1100"/>
              <a:ext cx="2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B4426F04-86C5-2E9C-A056-9528C9A3D1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2" y="1207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06A18822-6F65-02E8-C7EC-20273A0928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2" y="1304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89C79941-50C5-C689-6630-BABF84B5C3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2" y="1400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7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074234BE-570D-FFF9-14CA-2614BD2DDB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6" y="1100"/>
              <a:ext cx="15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0B14AC1D-3E32-BB74-D17E-F95BD8F795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2" y="1207"/>
              <a:ext cx="14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9348FC0C-86F8-4F26-9C26-2AF359B629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2" y="1304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9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B16AA8AB-FAED-78EA-87AB-DFF6EFF8E1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2" y="1400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3F40573E-032D-206C-1298-A9FE5820BE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3" y="1100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FC74C2DA-45FF-2618-9E98-7FEAE0DAF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" y="1207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16E307A9-4C9C-BF49-DB6C-292256A728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0" y="1304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7DDE9B6D-7281-6B0D-93A2-8EE7C33958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" y="1400"/>
              <a:ext cx="12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13E86CEA-8DA2-6E86-BCAA-13F31711DF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5" y="1583"/>
              <a:ext cx="17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3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E783303E-23AD-F220-7304-92616509D8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5" y="1100"/>
              <a:ext cx="24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8F837BAE-0EFA-A8D1-0D6C-A901B5CEF2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1" y="1207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7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232ED3BE-63BA-882D-7585-29A8279539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1" y="1304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5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F2226D7A-3703-0B98-49D1-3F2782C01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1" y="1400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07735EE7-13CD-0FF7-61D4-9DDA26BF1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5" y="1100"/>
              <a:ext cx="14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8A49F9B7-9DD0-12A9-A19D-F62C80DCC1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" y="1207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0F1CA57E-D8D7-1D51-93AD-47DA1DF702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1" y="1304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8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391A0482-CD14-1610-6495-3FC802B318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" y="1400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6EE35384-169E-D91E-4300-0432C7B920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" y="1100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E6958003-A6BE-45D9-D73E-05DB5472D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5" y="1207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FD3960B9-4D12-B4CA-5596-069526CD6E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5" y="130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B465E0ED-6FB0-3819-F394-89B46BDDE8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5" y="1400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D77468A4-1D33-DACE-DB44-AD557DF51F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9" y="1583"/>
              <a:ext cx="171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7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66AA5777-41B3-BCC2-3D28-3B172BEBB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6" y="1100"/>
              <a:ext cx="30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321CD73C-0B26-67FD-8D31-A9C611DA30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1" y="1207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3.2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38A07CA7-C94B-F08A-B8BD-A9EFD585CC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1" y="1304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3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3D7B71B4-63A4-C180-AAE0-A865BE6DBC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1" y="1400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3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07784034-57E0-DBBE-9356-DC7DFE269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6" y="1583"/>
              <a:ext cx="30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4E6ED339-1C4A-A034-5304-1FCEBD647F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6" y="1100"/>
              <a:ext cx="77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C00322B2-B912-EDE1-92EE-E3CAB8F39C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6" y="1207"/>
              <a:ext cx="68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41 [-0.75, -0.0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FF1A6966-0A1D-EEB2-9CAE-08A1CBCB5D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8" y="1304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72 [0.47, 0.9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7A0EB00A-E896-0169-0F20-0F1609371E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8" y="1400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74 [1.38, 2.1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00F34CBD-070A-871C-E546-4A7DF7ED2A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0" y="1583"/>
              <a:ext cx="64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0.68 [-0.41, 1.7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82C519C0-3A31-0BBC-8918-6F4841B67C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2" y="1004"/>
              <a:ext cx="403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1979A562-250F-3235-928A-99A2DFC390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6" y="1004"/>
              <a:ext cx="55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D3C1D0A7-4A35-B540-E739-78C51C41E9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3" y="1004"/>
              <a:ext cx="592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64B699C7-4281-3591-E927-626044B7A3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1" y="1004"/>
              <a:ext cx="591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B0A663F7-7B90-FB65-6177-4168CEDCF8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8" y="1100"/>
              <a:ext cx="78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Line 55">
              <a:extLst>
                <a:ext uri="{FF2B5EF4-FFF2-40B4-BE49-F238E27FC236}">
                  <a16:creationId xmlns:a16="http://schemas.microsoft.com/office/drawing/2014/main" id="{F4C56D9E-11F6-8AA4-EE81-089DA882C0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50" y="1173"/>
              <a:ext cx="0" cy="532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9" name="Line 56">
              <a:extLst>
                <a:ext uri="{FF2B5EF4-FFF2-40B4-BE49-F238E27FC236}">
                  <a16:creationId xmlns:a16="http://schemas.microsoft.com/office/drawing/2014/main" id="{56DA0F12-09A5-E297-1761-15E618D862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05" y="1222"/>
              <a:ext cx="131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BC6A8A20-6FA4-E2BF-9422-9F76A24540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8" y="1205"/>
              <a:ext cx="44" cy="45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1" name="Line 58">
              <a:extLst>
                <a:ext uri="{FF2B5EF4-FFF2-40B4-BE49-F238E27FC236}">
                  <a16:creationId xmlns:a16="http://schemas.microsoft.com/office/drawing/2014/main" id="{967B7F10-B556-B8DF-4E99-3B9AD3D293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41" y="1318"/>
              <a:ext cx="9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ABDC7AE9-6A3E-CF01-5E16-C8CECFF054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7" y="1302"/>
              <a:ext cx="44" cy="4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3" name="Line 60">
              <a:extLst>
                <a:ext uri="{FF2B5EF4-FFF2-40B4-BE49-F238E27FC236}">
                  <a16:creationId xmlns:a16="http://schemas.microsoft.com/office/drawing/2014/main" id="{F0B3120E-7DB2-8EB1-0352-BB9FCE5B90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7" y="1415"/>
              <a:ext cx="14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687A7A9A-5F20-8B55-06A5-18F11339E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5" y="1399"/>
              <a:ext cx="44" cy="4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5" name="Freeform 62">
              <a:extLst>
                <a:ext uri="{FF2B5EF4-FFF2-40B4-BE49-F238E27FC236}">
                  <a16:creationId xmlns:a16="http://schemas.microsoft.com/office/drawing/2014/main" id="{B4CE797F-5380-9DF8-26A1-97105A3EC38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6" y="1566"/>
              <a:ext cx="426" cy="84"/>
            </a:xfrm>
            <a:custGeom>
              <a:avLst/>
              <a:gdLst>
                <a:gd name="T0" fmla="*/ 720 w 1420"/>
                <a:gd name="T1" fmla="*/ 280 h 280"/>
                <a:gd name="T2" fmla="*/ 0 w 1420"/>
                <a:gd name="T3" fmla="*/ 140 h 280"/>
                <a:gd name="T4" fmla="*/ 720 w 1420"/>
                <a:gd name="T5" fmla="*/ 0 h 280"/>
                <a:gd name="T6" fmla="*/ 1420 w 1420"/>
                <a:gd name="T7" fmla="*/ 140 h 280"/>
                <a:gd name="T8" fmla="*/ 720 w 142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20" h="280">
                  <a:moveTo>
                    <a:pt x="720" y="280"/>
                  </a:moveTo>
                  <a:lnTo>
                    <a:pt x="0" y="140"/>
                  </a:lnTo>
                  <a:lnTo>
                    <a:pt x="720" y="0"/>
                  </a:lnTo>
                  <a:lnTo>
                    <a:pt x="1420" y="140"/>
                  </a:lnTo>
                  <a:lnTo>
                    <a:pt x="72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6" name="Line 63">
              <a:extLst>
                <a:ext uri="{FF2B5EF4-FFF2-40B4-BE49-F238E27FC236}">
                  <a16:creationId xmlns:a16="http://schemas.microsoft.com/office/drawing/2014/main" id="{A1C16642-954F-47AD-818C-1B3DC21C19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59" y="1705"/>
              <a:ext cx="198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7" name="Line 64">
              <a:extLst>
                <a:ext uri="{FF2B5EF4-FFF2-40B4-BE49-F238E27FC236}">
                  <a16:creationId xmlns:a16="http://schemas.microsoft.com/office/drawing/2014/main" id="{AAB5CABF-FB7A-5F80-672E-AABAF7EC17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74" y="1680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71387FFD-8F60-E47A-493E-B79E0BB85B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2" y="1738"/>
              <a:ext cx="10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Line 66">
              <a:extLst>
                <a:ext uri="{FF2B5EF4-FFF2-40B4-BE49-F238E27FC236}">
                  <a16:creationId xmlns:a16="http://schemas.microsoft.com/office/drawing/2014/main" id="{A77E7CEC-22E4-C9F1-7D3E-A09377FFE7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2" y="1680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D3A5379B-8304-1CFB-F5AC-AF4ACD2438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0" y="1738"/>
              <a:ext cx="10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Line 68">
              <a:extLst>
                <a:ext uri="{FF2B5EF4-FFF2-40B4-BE49-F238E27FC236}">
                  <a16:creationId xmlns:a16="http://schemas.microsoft.com/office/drawing/2014/main" id="{D33B3515-E6E8-CA60-4CA9-01ED44CE05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50" y="1680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13F21442-5A98-E245-47D0-552D08A1C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0" y="1738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Line 70">
              <a:extLst>
                <a:ext uri="{FF2B5EF4-FFF2-40B4-BE49-F238E27FC236}">
                  <a16:creationId xmlns:a16="http://schemas.microsoft.com/office/drawing/2014/main" id="{41EBF214-32AD-F111-B86C-71E1F67873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38" y="1680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E163BB0D-D483-4D86-A546-20BD2B49F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8" y="1738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Line 72">
              <a:extLst>
                <a:ext uri="{FF2B5EF4-FFF2-40B4-BE49-F238E27FC236}">
                  <a16:creationId xmlns:a16="http://schemas.microsoft.com/office/drawing/2014/main" id="{C02070EC-A00A-4227-7062-BC2866C1E0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26" y="1680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07F697FE-9612-27D5-5003-D3E78DEAFC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6" y="1738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02ECD4C5-6E4A-FD78-8D85-5F5052F92D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7" y="1827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59A0C17B-2088-02D4-CA12-0243020B8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0" y="1827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80133171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1</Words>
  <Application>Microsoft Office PowerPoint</Application>
  <PresentationFormat>宽屏</PresentationFormat>
  <Paragraphs>5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6:01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